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462" r:id="rId5"/>
  </p:sldIdLst>
  <p:sldSz cx="6858000" cy="9906000" type="A4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5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28612"/>
    <a:srgbClr val="F51515"/>
    <a:srgbClr val="FFFF00"/>
    <a:srgbClr val="FF0000"/>
    <a:srgbClr val="008000"/>
    <a:srgbClr val="0000FF"/>
    <a:srgbClr val="FF9121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4" d="100"/>
          <a:sy n="44" d="100"/>
        </p:scale>
        <p:origin x="225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Kyeremateng" userId="83302ce9-c164-4999-bfbb-7435b71d715b" providerId="ADAL" clId="{61F09017-3367-4353-A52A-561FDC06CB43}"/>
    <pc:docChg chg="modSld">
      <pc:chgData name="Daniel Kyeremateng" userId="83302ce9-c164-4999-bfbb-7435b71d715b" providerId="ADAL" clId="{61F09017-3367-4353-A52A-561FDC06CB43}" dt="2023-07-29T11:52:09.093" v="6" actId="207"/>
      <pc:docMkLst>
        <pc:docMk/>
      </pc:docMkLst>
      <pc:sldChg chg="modSp mod">
        <pc:chgData name="Daniel Kyeremateng" userId="83302ce9-c164-4999-bfbb-7435b71d715b" providerId="ADAL" clId="{61F09017-3367-4353-A52A-561FDC06CB43}" dt="2023-07-29T11:52:09.093" v="6" actId="207"/>
        <pc:sldMkLst>
          <pc:docMk/>
          <pc:sldMk cId="4208704407" sldId="462"/>
        </pc:sldMkLst>
        <pc:spChg chg="mod">
          <ac:chgData name="Daniel Kyeremateng" userId="83302ce9-c164-4999-bfbb-7435b71d715b" providerId="ADAL" clId="{61F09017-3367-4353-A52A-561FDC06CB43}" dt="2023-07-29T11:52:09.093" v="6" actId="207"/>
          <ac:spMkLst>
            <pc:docMk/>
            <pc:sldMk cId="4208704407" sldId="462"/>
            <ac:spMk id="2" creationId="{8488AEDB-E906-F290-BE55-1C474E9BCAD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983" cy="49958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923" y="0"/>
            <a:ext cx="2971982" cy="49958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05D7B7-CCD1-49F3-9CD2-3009CC5A665B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1243013"/>
            <a:ext cx="2325688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6347" y="4786364"/>
            <a:ext cx="5486400" cy="39161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103"/>
            <a:ext cx="2971983" cy="49958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923" y="9446103"/>
            <a:ext cx="2971982" cy="49958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3E3ACF-5738-4010-847A-FF0C39B627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8157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713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521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724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427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2861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2832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459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6780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524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431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53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119C3-B555-4B77-954E-314D70A46399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A46BC9-6910-42C1-BCC8-A26EA8B4C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73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A347A83-1555-A55B-83DD-9E9825645DB8}"/>
              </a:ext>
            </a:extLst>
          </p:cNvPr>
          <p:cNvGrpSpPr/>
          <p:nvPr/>
        </p:nvGrpSpPr>
        <p:grpSpPr>
          <a:xfrm>
            <a:off x="5579014" y="4628869"/>
            <a:ext cx="999986" cy="953442"/>
            <a:chOff x="5579014" y="3541211"/>
            <a:chExt cx="999986" cy="953442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830151AB-D18F-4F79-86D5-F15EA0A98F45}"/>
                </a:ext>
              </a:extLst>
            </p:cNvPr>
            <p:cNvSpPr/>
            <p:nvPr/>
          </p:nvSpPr>
          <p:spPr>
            <a:xfrm>
              <a:off x="5579014" y="3608873"/>
              <a:ext cx="144000" cy="144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EEFC708F-ED4E-45C4-8087-6BD37971E0CD}"/>
                </a:ext>
              </a:extLst>
            </p:cNvPr>
            <p:cNvSpPr/>
            <p:nvPr/>
          </p:nvSpPr>
          <p:spPr>
            <a:xfrm>
              <a:off x="5579014" y="3844654"/>
              <a:ext cx="144000" cy="144000"/>
            </a:xfrm>
            <a:prstGeom prst="rect">
              <a:avLst/>
            </a:prstGeom>
            <a:solidFill>
              <a:srgbClr val="00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E219491E-A6AE-4D41-A9AB-44476CFD4982}"/>
                </a:ext>
              </a:extLst>
            </p:cNvPr>
            <p:cNvSpPr/>
            <p:nvPr/>
          </p:nvSpPr>
          <p:spPr>
            <a:xfrm>
              <a:off x="5579014" y="4080435"/>
              <a:ext cx="144000" cy="144000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48CE6D4F-52A7-424D-9F3E-657155543498}"/>
                </a:ext>
              </a:extLst>
            </p:cNvPr>
            <p:cNvSpPr txBox="1"/>
            <p:nvPr/>
          </p:nvSpPr>
          <p:spPr>
            <a:xfrm>
              <a:off x="5676577" y="3541211"/>
              <a:ext cx="900342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L 0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EF181D51-E850-4B1F-97DC-507869E30D85}"/>
                </a:ext>
              </a:extLst>
            </p:cNvPr>
            <p:cNvSpPr txBox="1"/>
            <p:nvPr/>
          </p:nvSpPr>
          <p:spPr>
            <a:xfrm>
              <a:off x="5676577" y="3782008"/>
              <a:ext cx="900342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L 200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020B764-8CD1-443A-B0FE-731E4F29EA82}"/>
                </a:ext>
              </a:extLst>
            </p:cNvPr>
            <p:cNvSpPr txBox="1"/>
            <p:nvPr/>
          </p:nvSpPr>
          <p:spPr>
            <a:xfrm>
              <a:off x="5676577" y="4022805"/>
              <a:ext cx="900342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L 400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7BF33881-2FBF-4095-A856-087FF90E2AA4}"/>
                </a:ext>
              </a:extLst>
            </p:cNvPr>
            <p:cNvSpPr/>
            <p:nvPr/>
          </p:nvSpPr>
          <p:spPr>
            <a:xfrm>
              <a:off x="5581094" y="4316215"/>
              <a:ext cx="144000" cy="144000"/>
            </a:xfrm>
            <a:prstGeom prst="rect">
              <a:avLst/>
            </a:prstGeom>
            <a:solidFill>
              <a:srgbClr val="FF912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39392924-38C4-400B-9165-65151DB22F74}"/>
                </a:ext>
              </a:extLst>
            </p:cNvPr>
            <p:cNvSpPr txBox="1"/>
            <p:nvPr/>
          </p:nvSpPr>
          <p:spPr>
            <a:xfrm>
              <a:off x="5678658" y="4258587"/>
              <a:ext cx="900342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HL 600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B52DEDC8-386E-D826-B104-3B75E3F2B3B0}"/>
              </a:ext>
            </a:extLst>
          </p:cNvPr>
          <p:cNvGrpSpPr>
            <a:grpSpLocks noChangeAspect="1"/>
          </p:cNvGrpSpPr>
          <p:nvPr/>
        </p:nvGrpSpPr>
        <p:grpSpPr>
          <a:xfrm>
            <a:off x="270576" y="4018323"/>
            <a:ext cx="5143223" cy="2251175"/>
            <a:chOff x="533911" y="3401808"/>
            <a:chExt cx="8088773" cy="3365485"/>
          </a:xfrm>
        </p:grpSpPr>
        <p:pic>
          <p:nvPicPr>
            <p:cNvPr id="63" name="図 62">
              <a:extLst>
                <a:ext uri="{FF2B5EF4-FFF2-40B4-BE49-F238E27FC236}">
                  <a16:creationId xmlns:a16="http://schemas.microsoft.com/office/drawing/2014/main" id="{E247E27B-7B74-4C79-922C-0CC844E936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31150"/>
            <a:stretch/>
          </p:blipFill>
          <p:spPr>
            <a:xfrm>
              <a:off x="1115121" y="3670988"/>
              <a:ext cx="2478993" cy="2541600"/>
            </a:xfrm>
            <a:prstGeom prst="rect">
              <a:avLst/>
            </a:prstGeom>
          </p:spPr>
        </p:pic>
        <p:pic>
          <p:nvPicPr>
            <p:cNvPr id="64" name="図 63">
              <a:extLst>
                <a:ext uri="{FF2B5EF4-FFF2-40B4-BE49-F238E27FC236}">
                  <a16:creationId xmlns:a16="http://schemas.microsoft.com/office/drawing/2014/main" id="{8C4AEC3C-3AE1-45DF-9B86-554B787079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30993"/>
            <a:stretch/>
          </p:blipFill>
          <p:spPr>
            <a:xfrm>
              <a:off x="3595541" y="3688726"/>
              <a:ext cx="2484680" cy="2541600"/>
            </a:xfrm>
            <a:prstGeom prst="rect">
              <a:avLst/>
            </a:prstGeom>
          </p:spPr>
        </p:pic>
        <p:pic>
          <p:nvPicPr>
            <p:cNvPr id="67" name="図 66">
              <a:extLst>
                <a:ext uri="{FF2B5EF4-FFF2-40B4-BE49-F238E27FC236}">
                  <a16:creationId xmlns:a16="http://schemas.microsoft.com/office/drawing/2014/main" id="{40CC4553-80E7-4EE1-9A46-000BFB31BF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30886"/>
            <a:stretch/>
          </p:blipFill>
          <p:spPr>
            <a:xfrm>
              <a:off x="6134161" y="3688725"/>
              <a:ext cx="2488523" cy="2541600"/>
            </a:xfrm>
            <a:prstGeom prst="rect">
              <a:avLst/>
            </a:prstGeom>
          </p:spPr>
        </p:pic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DCE8F92D-E54A-473A-AFA7-0DC2D64733E8}"/>
                </a:ext>
              </a:extLst>
            </p:cNvPr>
            <p:cNvSpPr/>
            <p:nvPr/>
          </p:nvSpPr>
          <p:spPr>
            <a:xfrm>
              <a:off x="6820522" y="3401808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D2DC8474-97FD-4E59-B095-2CA4D4B7BD9C}"/>
                </a:ext>
              </a:extLst>
            </p:cNvPr>
            <p:cNvSpPr/>
            <p:nvPr/>
          </p:nvSpPr>
          <p:spPr>
            <a:xfrm>
              <a:off x="1947267" y="3675703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98E299C0-2AA2-4CA1-B23A-0311D895F0F6}"/>
                </a:ext>
              </a:extLst>
            </p:cNvPr>
            <p:cNvSpPr/>
            <p:nvPr/>
          </p:nvSpPr>
          <p:spPr>
            <a:xfrm>
              <a:off x="3134162" y="5303865"/>
              <a:ext cx="302720" cy="206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ED83AA49-26F8-47E1-B467-918001A91657}"/>
                </a:ext>
              </a:extLst>
            </p:cNvPr>
            <p:cNvSpPr/>
            <p:nvPr/>
          </p:nvSpPr>
          <p:spPr>
            <a:xfrm>
              <a:off x="6933166" y="3703293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8569324E-BA1D-4DC0-8FC3-B7EF900B724A}"/>
                </a:ext>
              </a:extLst>
            </p:cNvPr>
            <p:cNvSpPr/>
            <p:nvPr/>
          </p:nvSpPr>
          <p:spPr>
            <a:xfrm>
              <a:off x="6906664" y="6111880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3A1293A4-8AF0-4069-AE3D-CC6FE543EF2A}"/>
                </a:ext>
              </a:extLst>
            </p:cNvPr>
            <p:cNvSpPr/>
            <p:nvPr/>
          </p:nvSpPr>
          <p:spPr>
            <a:xfrm rot="16200000">
              <a:off x="5653484" y="4804550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46AA2D35-AA5A-4BD4-BB32-423F51CAF23F}"/>
                </a:ext>
              </a:extLst>
            </p:cNvPr>
            <p:cNvSpPr/>
            <p:nvPr/>
          </p:nvSpPr>
          <p:spPr>
            <a:xfrm>
              <a:off x="8196273" y="5318215"/>
              <a:ext cx="302720" cy="206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4F4794A5-C21F-4A02-B939-F6059C3F8DFA}"/>
                </a:ext>
              </a:extLst>
            </p:cNvPr>
            <p:cNvSpPr/>
            <p:nvPr/>
          </p:nvSpPr>
          <p:spPr>
            <a:xfrm>
              <a:off x="4352311" y="3696669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5D3DF0B6-995D-46E9-ACED-26479488A2B2}"/>
                </a:ext>
              </a:extLst>
            </p:cNvPr>
            <p:cNvSpPr/>
            <p:nvPr/>
          </p:nvSpPr>
          <p:spPr>
            <a:xfrm>
              <a:off x="4405321" y="6125134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352C738E-C5A2-44C2-B810-EA5880F51F25}"/>
                </a:ext>
              </a:extLst>
            </p:cNvPr>
            <p:cNvSpPr/>
            <p:nvPr/>
          </p:nvSpPr>
          <p:spPr>
            <a:xfrm rot="16200000">
              <a:off x="3105752" y="4781358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81431F06-5B75-434F-902C-EAC5D9B6E54C}"/>
                </a:ext>
              </a:extLst>
            </p:cNvPr>
            <p:cNvSpPr/>
            <p:nvPr/>
          </p:nvSpPr>
          <p:spPr>
            <a:xfrm>
              <a:off x="5648549" y="5314905"/>
              <a:ext cx="302720" cy="206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F069ECC3-0066-4931-A514-FE01C61A800F}"/>
                </a:ext>
              </a:extLst>
            </p:cNvPr>
            <p:cNvSpPr txBox="1"/>
            <p:nvPr/>
          </p:nvSpPr>
          <p:spPr>
            <a:xfrm>
              <a:off x="2071205" y="3457250"/>
              <a:ext cx="749039" cy="3911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25%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EA5270EB-D5AF-4E78-8FED-11019E64BED5}"/>
                </a:ext>
              </a:extLst>
            </p:cNvPr>
            <p:cNvSpPr txBox="1"/>
            <p:nvPr/>
          </p:nvSpPr>
          <p:spPr>
            <a:xfrm>
              <a:off x="4582274" y="3477492"/>
              <a:ext cx="749039" cy="3911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50%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D0331400-4C90-4A6C-9C64-7E5645781885}"/>
                </a:ext>
              </a:extLst>
            </p:cNvPr>
            <p:cNvSpPr txBox="1"/>
            <p:nvPr/>
          </p:nvSpPr>
          <p:spPr>
            <a:xfrm>
              <a:off x="7090245" y="3477492"/>
              <a:ext cx="749039" cy="3911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75%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45" name="直線矢印コネクタ 44">
              <a:extLst>
                <a:ext uri="{FF2B5EF4-FFF2-40B4-BE49-F238E27FC236}">
                  <a16:creationId xmlns:a16="http://schemas.microsoft.com/office/drawing/2014/main" id="{3BA6A217-65D3-4467-9FA8-91A6C3924598}"/>
                </a:ext>
              </a:extLst>
            </p:cNvPr>
            <p:cNvCxnSpPr/>
            <p:nvPr/>
          </p:nvCxnSpPr>
          <p:spPr>
            <a:xfrm flipV="1">
              <a:off x="1016381" y="3417597"/>
              <a:ext cx="0" cy="28800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直線矢印コネクタ 45">
              <a:extLst>
                <a:ext uri="{FF2B5EF4-FFF2-40B4-BE49-F238E27FC236}">
                  <a16:creationId xmlns:a16="http://schemas.microsoft.com/office/drawing/2014/main" id="{D9D32C7F-B744-441A-9D5C-80B02DEC7819}"/>
                </a:ext>
              </a:extLst>
            </p:cNvPr>
            <p:cNvCxnSpPr/>
            <p:nvPr/>
          </p:nvCxnSpPr>
          <p:spPr>
            <a:xfrm flipV="1">
              <a:off x="1016381" y="6309638"/>
              <a:ext cx="756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F2540378-62EA-4A46-AF5C-71F65095EC8B}"/>
                </a:ext>
              </a:extLst>
            </p:cNvPr>
            <p:cNvSpPr txBox="1"/>
            <p:nvPr/>
          </p:nvSpPr>
          <p:spPr>
            <a:xfrm>
              <a:off x="2999925" y="6376189"/>
              <a:ext cx="3940241" cy="3911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Fluorescence intensity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5E966155-2B1E-4E15-B469-F0B9A42059B6}"/>
                </a:ext>
              </a:extLst>
            </p:cNvPr>
            <p:cNvSpPr txBox="1"/>
            <p:nvPr/>
          </p:nvSpPr>
          <p:spPr>
            <a:xfrm rot="16200000">
              <a:off x="-150597" y="4707907"/>
              <a:ext cx="1780451" cy="41143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ount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5D71C635-85B6-3BD1-50A0-2BD6B4026863}"/>
                </a:ext>
              </a:extLst>
            </p:cNvPr>
            <p:cNvSpPr/>
            <p:nvPr/>
          </p:nvSpPr>
          <p:spPr>
            <a:xfrm>
              <a:off x="1926281" y="6094654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F5215FAF-F4D9-7C0B-2EF8-D3EDAEF09019}"/>
                </a:ext>
              </a:extLst>
            </p:cNvPr>
            <p:cNvSpPr/>
            <p:nvPr/>
          </p:nvSpPr>
          <p:spPr>
            <a:xfrm rot="16200000">
              <a:off x="626712" y="4750878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CB7C070B-6F95-395C-A55E-490ECC38A5F8}"/>
              </a:ext>
            </a:extLst>
          </p:cNvPr>
          <p:cNvGrpSpPr>
            <a:grpSpLocks noChangeAspect="1"/>
          </p:cNvGrpSpPr>
          <p:nvPr/>
        </p:nvGrpSpPr>
        <p:grpSpPr>
          <a:xfrm>
            <a:off x="266229" y="1079910"/>
            <a:ext cx="5149341" cy="2234808"/>
            <a:chOff x="533909" y="3427757"/>
            <a:chExt cx="8098526" cy="3339340"/>
          </a:xfrm>
        </p:grpSpPr>
        <p:pic>
          <p:nvPicPr>
            <p:cNvPr id="55" name="図 54">
              <a:extLst>
                <a:ext uri="{FF2B5EF4-FFF2-40B4-BE49-F238E27FC236}">
                  <a16:creationId xmlns:a16="http://schemas.microsoft.com/office/drawing/2014/main" id="{1F2EC57B-3D86-DB02-7A1B-52A329A3D1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449" t="5015" r="31140" b="5015"/>
            <a:stretch/>
          </p:blipFill>
          <p:spPr>
            <a:xfrm>
              <a:off x="1299235" y="3808018"/>
              <a:ext cx="2304000" cy="2271731"/>
            </a:xfrm>
            <a:prstGeom prst="rect">
              <a:avLst/>
            </a:prstGeom>
          </p:spPr>
        </p:pic>
        <p:pic>
          <p:nvPicPr>
            <p:cNvPr id="56" name="図 55">
              <a:extLst>
                <a:ext uri="{FF2B5EF4-FFF2-40B4-BE49-F238E27FC236}">
                  <a16:creationId xmlns:a16="http://schemas.microsoft.com/office/drawing/2014/main" id="{C38A6E1D-874D-37CE-01EE-5533C17D28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450" t="5015" r="31139" b="5015"/>
            <a:stretch/>
          </p:blipFill>
          <p:spPr>
            <a:xfrm>
              <a:off x="3785179" y="3822298"/>
              <a:ext cx="2304000" cy="2271732"/>
            </a:xfrm>
            <a:prstGeom prst="rect">
              <a:avLst/>
            </a:prstGeom>
          </p:spPr>
        </p:pic>
        <p:pic>
          <p:nvPicPr>
            <p:cNvPr id="57" name="図 56">
              <a:extLst>
                <a:ext uri="{FF2B5EF4-FFF2-40B4-BE49-F238E27FC236}">
                  <a16:creationId xmlns:a16="http://schemas.microsoft.com/office/drawing/2014/main" id="{2955C294-2089-8A57-6643-13204A74B7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450" t="5015" r="31139" b="5015"/>
            <a:stretch/>
          </p:blipFill>
          <p:spPr>
            <a:xfrm>
              <a:off x="6328435" y="3822298"/>
              <a:ext cx="2304000" cy="2271731"/>
            </a:xfrm>
            <a:prstGeom prst="rect">
              <a:avLst/>
            </a:prstGeom>
          </p:spPr>
        </p:pic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2EBDAD48-7C0C-66B3-D6DC-9383AD25F458}"/>
                </a:ext>
              </a:extLst>
            </p:cNvPr>
            <p:cNvSpPr/>
            <p:nvPr/>
          </p:nvSpPr>
          <p:spPr>
            <a:xfrm>
              <a:off x="1811642" y="6104368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78A3F316-6D53-0A32-C5B6-4358BAC75822}"/>
                </a:ext>
              </a:extLst>
            </p:cNvPr>
            <p:cNvSpPr/>
            <p:nvPr/>
          </p:nvSpPr>
          <p:spPr>
            <a:xfrm>
              <a:off x="1957427" y="3685863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5F1AA080-45C5-DD8F-3D5B-49D53D266401}"/>
                </a:ext>
              </a:extLst>
            </p:cNvPr>
            <p:cNvSpPr/>
            <p:nvPr/>
          </p:nvSpPr>
          <p:spPr>
            <a:xfrm rot="16200000">
              <a:off x="637973" y="4826861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62E8FEE8-430A-3431-C721-28D5B17C5485}"/>
                </a:ext>
              </a:extLst>
            </p:cNvPr>
            <p:cNvSpPr/>
            <p:nvPr/>
          </p:nvSpPr>
          <p:spPr>
            <a:xfrm>
              <a:off x="3118921" y="5178557"/>
              <a:ext cx="302720" cy="206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B1DD7539-A43A-DA32-849A-04B4FA603024}"/>
                </a:ext>
              </a:extLst>
            </p:cNvPr>
            <p:cNvSpPr/>
            <p:nvPr/>
          </p:nvSpPr>
          <p:spPr>
            <a:xfrm>
              <a:off x="6953486" y="3703293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78816F22-B13A-D9F5-9932-F0A8668A6685}"/>
                </a:ext>
              </a:extLst>
            </p:cNvPr>
            <p:cNvSpPr/>
            <p:nvPr/>
          </p:nvSpPr>
          <p:spPr>
            <a:xfrm>
              <a:off x="6926984" y="6111880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862E321D-39FB-AFC3-E6FC-534781963D95}"/>
                </a:ext>
              </a:extLst>
            </p:cNvPr>
            <p:cNvSpPr/>
            <p:nvPr/>
          </p:nvSpPr>
          <p:spPr>
            <a:xfrm rot="16200000">
              <a:off x="5673804" y="4804550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60F23246-9936-FEDD-AB0F-C31D67F4165B}"/>
                </a:ext>
              </a:extLst>
            </p:cNvPr>
            <p:cNvSpPr/>
            <p:nvPr/>
          </p:nvSpPr>
          <p:spPr>
            <a:xfrm>
              <a:off x="8250461" y="5148876"/>
              <a:ext cx="288000" cy="206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256775F8-C1E4-CBA1-695D-5ED5459B0C67}"/>
                </a:ext>
              </a:extLst>
            </p:cNvPr>
            <p:cNvSpPr/>
            <p:nvPr/>
          </p:nvSpPr>
          <p:spPr>
            <a:xfrm>
              <a:off x="4372631" y="3696669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49AD4DFD-CCE5-790F-E1C3-0AC9016583EA}"/>
                </a:ext>
              </a:extLst>
            </p:cNvPr>
            <p:cNvSpPr/>
            <p:nvPr/>
          </p:nvSpPr>
          <p:spPr>
            <a:xfrm>
              <a:off x="4425641" y="6125134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A7F7B022-D915-6CDA-B33C-3B1D943364C7}"/>
                </a:ext>
              </a:extLst>
            </p:cNvPr>
            <p:cNvSpPr/>
            <p:nvPr/>
          </p:nvSpPr>
          <p:spPr>
            <a:xfrm rot="16200000">
              <a:off x="3126072" y="4781358"/>
              <a:ext cx="1116201" cy="117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943C1772-8662-E08C-C953-18ECAF7E419C}"/>
                </a:ext>
              </a:extLst>
            </p:cNvPr>
            <p:cNvSpPr/>
            <p:nvPr/>
          </p:nvSpPr>
          <p:spPr>
            <a:xfrm>
              <a:off x="5711204" y="5137106"/>
              <a:ext cx="288000" cy="206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E0B70CD2-9980-2E75-0AFB-3523DA5A2C53}"/>
                </a:ext>
              </a:extLst>
            </p:cNvPr>
            <p:cNvSpPr txBox="1"/>
            <p:nvPr/>
          </p:nvSpPr>
          <p:spPr>
            <a:xfrm>
              <a:off x="2081364" y="3467410"/>
              <a:ext cx="749040" cy="390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25%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7CC0649D-70E1-FDD0-3B16-2BBFC2B1741B}"/>
                </a:ext>
              </a:extLst>
            </p:cNvPr>
            <p:cNvSpPr txBox="1"/>
            <p:nvPr/>
          </p:nvSpPr>
          <p:spPr>
            <a:xfrm>
              <a:off x="4602595" y="3477490"/>
              <a:ext cx="749040" cy="390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50%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24F1A936-5481-E011-C9D5-7A655938EB2F}"/>
                </a:ext>
              </a:extLst>
            </p:cNvPr>
            <p:cNvSpPr txBox="1"/>
            <p:nvPr/>
          </p:nvSpPr>
          <p:spPr>
            <a:xfrm>
              <a:off x="7110563" y="3477490"/>
              <a:ext cx="749040" cy="390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75%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80" name="直線矢印コネクタ 79">
              <a:extLst>
                <a:ext uri="{FF2B5EF4-FFF2-40B4-BE49-F238E27FC236}">
                  <a16:creationId xmlns:a16="http://schemas.microsoft.com/office/drawing/2014/main" id="{F9A079B3-4E40-4FE9-92F9-9AE008E9CE3B}"/>
                </a:ext>
              </a:extLst>
            </p:cNvPr>
            <p:cNvCxnSpPr/>
            <p:nvPr/>
          </p:nvCxnSpPr>
          <p:spPr>
            <a:xfrm flipV="1">
              <a:off x="1016381" y="3427757"/>
              <a:ext cx="0" cy="28800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直線矢印コネクタ 80">
              <a:extLst>
                <a:ext uri="{FF2B5EF4-FFF2-40B4-BE49-F238E27FC236}">
                  <a16:creationId xmlns:a16="http://schemas.microsoft.com/office/drawing/2014/main" id="{010FD27C-6DC4-2DF9-5914-FC818337DE9A}"/>
                </a:ext>
              </a:extLst>
            </p:cNvPr>
            <p:cNvCxnSpPr/>
            <p:nvPr/>
          </p:nvCxnSpPr>
          <p:spPr>
            <a:xfrm flipV="1">
              <a:off x="1016381" y="6309638"/>
              <a:ext cx="756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43F0B319-6125-EF6F-6D3F-3D0BD04EA73D}"/>
                </a:ext>
              </a:extLst>
            </p:cNvPr>
            <p:cNvSpPr txBox="1"/>
            <p:nvPr/>
          </p:nvSpPr>
          <p:spPr>
            <a:xfrm>
              <a:off x="2999926" y="6376189"/>
              <a:ext cx="3940242" cy="39090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Fluorescence intensity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EC6F45E9-99C9-87B4-E38E-71B37A4CD4D1}"/>
                </a:ext>
              </a:extLst>
            </p:cNvPr>
            <p:cNvSpPr txBox="1"/>
            <p:nvPr/>
          </p:nvSpPr>
          <p:spPr>
            <a:xfrm rot="16200000">
              <a:off x="-150596" y="4738381"/>
              <a:ext cx="1780451" cy="41144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ount</a:t>
              </a:r>
              <a:endPara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C5482900-60F9-A899-30F9-B100EC49BE29}"/>
              </a:ext>
            </a:extLst>
          </p:cNvPr>
          <p:cNvGrpSpPr/>
          <p:nvPr/>
        </p:nvGrpSpPr>
        <p:grpSpPr>
          <a:xfrm>
            <a:off x="5579014" y="1693160"/>
            <a:ext cx="1107644" cy="953442"/>
            <a:chOff x="5579014" y="6390304"/>
            <a:chExt cx="1107644" cy="953442"/>
          </a:xfrm>
        </p:grpSpPr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542B7440-1B4D-196B-04FC-9AB984410AD2}"/>
                </a:ext>
              </a:extLst>
            </p:cNvPr>
            <p:cNvSpPr/>
            <p:nvPr/>
          </p:nvSpPr>
          <p:spPr>
            <a:xfrm>
              <a:off x="5579014" y="6457966"/>
              <a:ext cx="144000" cy="144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EF741451-F4C2-DAB1-C3AE-6AC93BDA1B55}"/>
                </a:ext>
              </a:extLst>
            </p:cNvPr>
            <p:cNvSpPr/>
            <p:nvPr/>
          </p:nvSpPr>
          <p:spPr>
            <a:xfrm>
              <a:off x="5579014" y="6693747"/>
              <a:ext cx="144000" cy="144000"/>
            </a:xfrm>
            <a:prstGeom prst="rect">
              <a:avLst/>
            </a:prstGeom>
            <a:solidFill>
              <a:srgbClr val="00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12326083-C0D7-83AC-6BBC-84C9010D7B3D}"/>
                </a:ext>
              </a:extLst>
            </p:cNvPr>
            <p:cNvSpPr/>
            <p:nvPr/>
          </p:nvSpPr>
          <p:spPr>
            <a:xfrm>
              <a:off x="5579014" y="6929528"/>
              <a:ext cx="144000" cy="144000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5223171B-D00A-267A-0761-796066AF6C1F}"/>
                </a:ext>
              </a:extLst>
            </p:cNvPr>
            <p:cNvSpPr txBox="1"/>
            <p:nvPr/>
          </p:nvSpPr>
          <p:spPr>
            <a:xfrm>
              <a:off x="5676577" y="6390304"/>
              <a:ext cx="1008000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DOX 0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2587C8CC-F8BC-9E9D-5824-2D8EEAC14080}"/>
                </a:ext>
              </a:extLst>
            </p:cNvPr>
            <p:cNvSpPr txBox="1"/>
            <p:nvPr/>
          </p:nvSpPr>
          <p:spPr>
            <a:xfrm>
              <a:off x="5676577" y="6631101"/>
              <a:ext cx="1008000" cy="386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DOX 0.1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50B220D5-456D-1D9B-31CC-827AADB64C42}"/>
                </a:ext>
              </a:extLst>
            </p:cNvPr>
            <p:cNvSpPr txBox="1"/>
            <p:nvPr/>
          </p:nvSpPr>
          <p:spPr>
            <a:xfrm>
              <a:off x="5676577" y="6871900"/>
              <a:ext cx="1008000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DOX 1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75C73B95-785D-CF41-239C-E3D9DDC4DDE2}"/>
                </a:ext>
              </a:extLst>
            </p:cNvPr>
            <p:cNvSpPr/>
            <p:nvPr/>
          </p:nvSpPr>
          <p:spPr>
            <a:xfrm>
              <a:off x="5581094" y="7165308"/>
              <a:ext cx="144000" cy="144000"/>
            </a:xfrm>
            <a:prstGeom prst="rect">
              <a:avLst/>
            </a:prstGeom>
            <a:solidFill>
              <a:srgbClr val="FF912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51A8AD60-C1BB-E3B0-FCF5-AEA458E575F4}"/>
                </a:ext>
              </a:extLst>
            </p:cNvPr>
            <p:cNvSpPr txBox="1"/>
            <p:nvPr/>
          </p:nvSpPr>
          <p:spPr>
            <a:xfrm>
              <a:off x="5678658" y="7107680"/>
              <a:ext cx="1008000" cy="236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：</a:t>
              </a:r>
              <a:r>
                <a:rPr kumimoji="1" lang="en-US" altLang="ja-JP" sz="105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DOX 10 µM</a:t>
              </a:r>
              <a:endParaRPr kumimoji="1" lang="ja-JP" altLang="en-US" sz="105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楕円 4">
            <a:extLst>
              <a:ext uri="{FF2B5EF4-FFF2-40B4-BE49-F238E27FC236}">
                <a16:creationId xmlns:a16="http://schemas.microsoft.com/office/drawing/2014/main" id="{6A1344E5-4B1A-F827-1AE2-0CAABCD8715B}"/>
              </a:ext>
            </a:extLst>
          </p:cNvPr>
          <p:cNvSpPr/>
          <p:nvPr/>
        </p:nvSpPr>
        <p:spPr>
          <a:xfrm>
            <a:off x="182410" y="301181"/>
            <a:ext cx="502040" cy="502039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b="1" dirty="0">
                <a:solidFill>
                  <a:schemeClr val="tx1"/>
                </a:solidFill>
              </a:rPr>
              <a:t>S1</a:t>
            </a:r>
            <a:endParaRPr kumimoji="1" lang="ja-JP" altLang="en-US" sz="1200" b="1" dirty="0">
              <a:solidFill>
                <a:schemeClr val="tx1"/>
              </a:solidFill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6549F42-81D1-F07C-F8B6-ECB711EF0F30}"/>
              </a:ext>
            </a:extLst>
          </p:cNvPr>
          <p:cNvSpPr txBox="1"/>
          <p:nvPr/>
        </p:nvSpPr>
        <p:spPr>
          <a:xfrm>
            <a:off x="897229" y="799729"/>
            <a:ext cx="432000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ixing ratio</a:t>
            </a:r>
            <a:r>
              <a: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f HuH-7 cells</a:t>
            </a:r>
            <a:r>
              <a: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t</a:t>
            </a:r>
            <a:r>
              <a: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eeding</a:t>
            </a:r>
            <a:endParaRPr kumimoji="1" lang="ja-JP" altLang="en-US" sz="11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7542D70-975B-4C41-BB6B-0FDE5E43BE47}"/>
              </a:ext>
            </a:extLst>
          </p:cNvPr>
          <p:cNvSpPr txBox="1"/>
          <p:nvPr/>
        </p:nvSpPr>
        <p:spPr>
          <a:xfrm>
            <a:off x="895624" y="3724219"/>
            <a:ext cx="432000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ixing ratio</a:t>
            </a:r>
            <a:r>
              <a: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f HuH-7 cells</a:t>
            </a:r>
            <a:r>
              <a: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t</a:t>
            </a:r>
            <a:r>
              <a:rPr kumimoji="1" lang="ja-JP" altLang="en-US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eeding</a:t>
            </a:r>
            <a:endParaRPr kumimoji="1" lang="ja-JP" altLang="en-US" sz="11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25">
            <a:extLst>
              <a:ext uri="{FF2B5EF4-FFF2-40B4-BE49-F238E27FC236}">
                <a16:creationId xmlns:a16="http://schemas.microsoft.com/office/drawing/2014/main" id="{8488AEDB-E906-F290-BE55-1C474E9BCADE}"/>
              </a:ext>
            </a:extLst>
          </p:cNvPr>
          <p:cNvSpPr txBox="1"/>
          <p:nvPr/>
        </p:nvSpPr>
        <p:spPr>
          <a:xfrm>
            <a:off x="488950" y="6941500"/>
            <a:ext cx="5880100" cy="251777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l"/>
            <a:r>
              <a:rPr lang="en-US" sz="105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1</a:t>
            </a:r>
          </a:p>
          <a:p>
            <a:pPr algn="l"/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uH-7 cells were labeled with a green dye and mixed with unlabeled </a:t>
            </a:r>
            <a:r>
              <a:rPr lang="en-US" sz="105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c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ells such that the percentage of HuH-7 cells to the total cells was 0, 25, 50, 75, and 100%. (</a:t>
            </a:r>
            <a:r>
              <a:rPr lang="en-US" sz="105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low cytometric analysis of mixed cells treated with DOX for 48 h. Data represent the mean</a:t>
            </a:r>
            <a:r>
              <a:rPr lang="ja-JP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±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E (n = 4).</a:t>
            </a:r>
            <a:r>
              <a:rPr lang="en-US" sz="105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Flow cytometric analysis of mixed cells treated with HL for 48 h. Data represent the mean</a:t>
            </a:r>
            <a:r>
              <a:rPr lang="ja-JP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±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E (n = 4).</a:t>
            </a:r>
            <a:endParaRPr lang="ja-JP" sz="105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8704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783E9FF08A402E4FB2E270793B93735E" ma:contentTypeVersion="6" ma:contentTypeDescription="新しいドキュメントを作成します。" ma:contentTypeScope="" ma:versionID="e8651d8e1d44024e1f5bb370b7e6013c">
  <xsd:schema xmlns:xsd="http://www.w3.org/2001/XMLSchema" xmlns:xs="http://www.w3.org/2001/XMLSchema" xmlns:p="http://schemas.microsoft.com/office/2006/metadata/properties" xmlns:ns2="c3cb213d-621a-4a78-a3a4-808f40796f47" targetNamespace="http://schemas.microsoft.com/office/2006/metadata/properties" ma:root="true" ma:fieldsID="64f20baafa53b4bc381920d6fa4925a9" ns2:_="">
    <xsd:import namespace="c3cb213d-621a-4a78-a3a4-808f40796f4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3cb213d-621a-4a78-a3a4-808f40796f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BC9ACC0-2A52-491B-A803-4AF2D5F5520B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c3cb213d-621a-4a78-a3a4-808f40796f47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2A83E31-002B-4439-81E0-7BF3D4BD7E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3cb213d-621a-4a78-a3a4-808f40796f4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C511232-C0F5-4BE6-97D7-DE6EBCEFDE9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024</TotalTime>
  <Words>159</Words>
  <Application>Microsoft Office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inno</dc:creator>
  <cp:lastModifiedBy>jinno</cp:lastModifiedBy>
  <cp:revision>357</cp:revision>
  <cp:lastPrinted>2021-11-24T23:51:04Z</cp:lastPrinted>
  <dcterms:created xsi:type="dcterms:W3CDTF">2020-11-24T02:24:54Z</dcterms:created>
  <dcterms:modified xsi:type="dcterms:W3CDTF">2023-08-09T08:30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3E9FF08A402E4FB2E270793B93735E</vt:lpwstr>
  </property>
</Properties>
</file>